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16" autoAdjust="0"/>
    <p:restoredTop sz="94660"/>
  </p:normalViewPr>
  <p:slideViewPr>
    <p:cSldViewPr snapToGrid="0">
      <p:cViewPr>
        <p:scale>
          <a:sx n="70" d="100"/>
          <a:sy n="70" d="100"/>
        </p:scale>
        <p:origin x="330" y="8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8B4EE5A-7CBF-4A38-BFD7-424C450FF2E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379F888-D2F2-491F-8187-D5411290F5C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3508498-DBCB-4C33-A26E-2AF56A4E7B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F50D4E-3410-4EF4-A2E8-627712FE37AD}" type="datetimeFigureOut">
              <a:rPr lang="en-US" smtClean="0"/>
              <a:t>3/5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C168F76-85FF-4E92-9E76-650FE7C6FF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139A9D4-888F-41CB-83AB-44A2FC2482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968B01-3933-4432-98E7-2AEF0EFBC2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766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CA89060-B279-400A-9B4E-D42B9F2172E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381E775-FB37-408E-86F2-99B34D43CC6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914D3FD-9713-42A3-8C46-E0BEFBD7FA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F50D4E-3410-4EF4-A2E8-627712FE37AD}" type="datetimeFigureOut">
              <a:rPr lang="en-US" smtClean="0"/>
              <a:t>3/5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97B2652-2559-418D-9362-499376752F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F41018D-8D15-4050-9EC5-3B28067AFD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968B01-3933-4432-98E7-2AEF0EFBC2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29061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E2F877E-4112-4974-8DE7-6D50043BEA8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758FB3F-EAFC-4C9B-BE67-5800712E563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5198677-40AB-4F67-8D68-4AF5CFCFD8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F50D4E-3410-4EF4-A2E8-627712FE37AD}" type="datetimeFigureOut">
              <a:rPr lang="en-US" smtClean="0"/>
              <a:t>3/5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F897342-D97F-4D65-967C-5BB2EDB34E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24A5FA2-999A-4538-999A-7FFC047FD1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968B01-3933-4432-98E7-2AEF0EFBC2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88111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954CB3C-9E3B-474B-820B-3C9F9D72463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7638654-A127-4B06-B0C9-CABB69D368A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9CACB40-CD8D-4871-AB52-5F87B993AF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F50D4E-3410-4EF4-A2E8-627712FE37AD}" type="datetimeFigureOut">
              <a:rPr lang="en-US" smtClean="0"/>
              <a:t>3/5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F9F9AF6-B665-4087-8CBA-510B5390E9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5C197D2-7754-44E2-80A0-ABA68350E6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968B01-3933-4432-98E7-2AEF0EFBC2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00664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1901525-DEB5-4495-8578-8AFEC7F9EB3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912658C-A1C6-4B4F-92CF-5077AE94FBA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1C6F6A8-7AA4-416C-AB30-70C5173C04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F50D4E-3410-4EF4-A2E8-627712FE37AD}" type="datetimeFigureOut">
              <a:rPr lang="en-US" smtClean="0"/>
              <a:t>3/5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078C6F5-7038-4856-B521-BE8F535709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FC171F1-FCAB-44CD-89AD-DD9E634EC7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968B01-3933-4432-98E7-2AEF0EFBC2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28172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47634D-D11B-48D3-A8BE-1F50B5148B5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12B3AC0-1554-4E6F-A136-E6BB17902A4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4C8EB40-5678-475C-A6E9-714B4441C74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E71BBE9-AF74-444B-BEBB-2F2E77BF9C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F50D4E-3410-4EF4-A2E8-627712FE37AD}" type="datetimeFigureOut">
              <a:rPr lang="en-US" smtClean="0"/>
              <a:t>3/5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9F1C3C1-C099-4071-BAC4-6CA3E1DBE3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16C808E-513B-4AF3-BB1C-995CBE978B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968B01-3933-4432-98E7-2AEF0EFBC2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31441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10C7137-ADDC-40E2-8F04-B2D9040389B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F557A80-8A73-4885-9507-C71769EEEF3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70E0C93-0AC2-4E85-9B41-BA7BB97686F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2F6F9A9-B13A-4856-AE57-856A54E3ECF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82AB3A7-D030-46DD-A13D-8FEB778BB71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F698811-AC0F-4D0F-9DFA-ED1F255B8D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F50D4E-3410-4EF4-A2E8-627712FE37AD}" type="datetimeFigureOut">
              <a:rPr lang="en-US" smtClean="0"/>
              <a:t>3/5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4D9BD1B-D258-4E03-8B79-10E3230658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5618394-567B-4C7C-942B-32CCAA05C1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968B01-3933-4432-98E7-2AEF0EFBC2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00372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5277B9E-6A0A-463E-8852-BA9033A2667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CDEF970-7E68-43DD-9AE6-B7AB112325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F50D4E-3410-4EF4-A2E8-627712FE37AD}" type="datetimeFigureOut">
              <a:rPr lang="en-US" smtClean="0"/>
              <a:t>3/5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0E2485F-BE97-42E4-BE03-5EE037757E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0E0ADE0-04EA-485A-B832-AADDA3DAD9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968B01-3933-4432-98E7-2AEF0EFBC2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18237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9500071-C102-4817-AFD3-24CA1968EB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F50D4E-3410-4EF4-A2E8-627712FE37AD}" type="datetimeFigureOut">
              <a:rPr lang="en-US" smtClean="0"/>
              <a:t>3/5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54B299C-B247-4BA8-8B8B-410BA1CCFC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0988965-9D3B-4A98-9ADA-A8C0949D38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968B01-3933-4432-98E7-2AEF0EFBC2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94429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FA17E37-557D-4E07-B4D2-9FD4DE82CF2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37C03C1-B65C-4D94-B959-5842D85DD6A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4273397-807F-4197-B8D6-4563F5CC252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62D2A70-9191-4EF0-ADB6-0527D652A1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F50D4E-3410-4EF4-A2E8-627712FE37AD}" type="datetimeFigureOut">
              <a:rPr lang="en-US" smtClean="0"/>
              <a:t>3/5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6EEE460-99A8-4251-A581-E0A6FF6F42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E07CE11-D01C-4C9E-95BA-A4BDC8EA8C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968B01-3933-4432-98E7-2AEF0EFBC2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47401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EF38FFF-92AB-4C5B-BD7F-8CD3AB209A3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3FC45F4-AA3E-4C8C-8E7C-E2FCFDA6227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BABEFE0-E2E1-4934-B956-A0744AC44B4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FC9FB28-1652-46C1-A5BD-8FA4944A41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F50D4E-3410-4EF4-A2E8-627712FE37AD}" type="datetimeFigureOut">
              <a:rPr lang="en-US" smtClean="0"/>
              <a:t>3/5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414FD75-F53B-46F0-BADE-9E00D50565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51DE6E7-AA98-4C3E-A03C-C0E96457E4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968B01-3933-4432-98E7-2AEF0EFBC2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68131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8F98FE8-B42C-4C82-A610-617D38885C5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9E676E2-1934-4F18-B23E-D0194F21C5E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D5E12BB-0C91-43BB-A1A0-7C27C9EDD2C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F50D4E-3410-4EF4-A2E8-627712FE37AD}" type="datetimeFigureOut">
              <a:rPr lang="en-US" smtClean="0"/>
              <a:t>3/5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8866801-15D5-4FC9-975C-8A94D6EA491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8ED4AD6-C53C-48D3-9EA6-67CD6C07CA1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68B01-3933-4432-98E7-2AEF0EFBC2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12983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7" Type="http://schemas.openxmlformats.org/officeDocument/2006/relationships/image" Target="../media/image6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g"/><Relationship Id="rId5" Type="http://schemas.openxmlformats.org/officeDocument/2006/relationships/image" Target="../media/image4.jpg"/><Relationship Id="rId4" Type="http://schemas.openxmlformats.org/officeDocument/2006/relationships/image" Target="../media/image3.jp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g"/><Relationship Id="rId7" Type="http://schemas.openxmlformats.org/officeDocument/2006/relationships/image" Target="../media/image12.jpg"/><Relationship Id="rId2" Type="http://schemas.openxmlformats.org/officeDocument/2006/relationships/image" Target="../media/image7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.jpg"/><Relationship Id="rId5" Type="http://schemas.openxmlformats.org/officeDocument/2006/relationships/image" Target="../media/image10.jpg"/><Relationship Id="rId4" Type="http://schemas.openxmlformats.org/officeDocument/2006/relationships/image" Target="../media/image9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4" name="Picture 23">
            <a:extLst>
              <a:ext uri="{FF2B5EF4-FFF2-40B4-BE49-F238E27FC236}">
                <a16:creationId xmlns:a16="http://schemas.microsoft.com/office/drawing/2014/main" id="{C1EE17BA-CBA4-46D6-93E5-DA768E129AB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21170" y="3674661"/>
            <a:ext cx="3323589" cy="2743200"/>
          </a:xfrm>
          <a:prstGeom prst="rect">
            <a:avLst/>
          </a:prstGeom>
        </p:spPr>
      </p:pic>
      <p:pic>
        <p:nvPicPr>
          <p:cNvPr id="26" name="Picture 25">
            <a:extLst>
              <a:ext uri="{FF2B5EF4-FFF2-40B4-BE49-F238E27FC236}">
                <a16:creationId xmlns:a16="http://schemas.microsoft.com/office/drawing/2014/main" id="{0D9A09D5-3B15-4BF7-8F45-ED94C001505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44791" y="3674661"/>
            <a:ext cx="3323589" cy="2743200"/>
          </a:xfrm>
          <a:prstGeom prst="rect">
            <a:avLst/>
          </a:prstGeom>
        </p:spPr>
      </p:pic>
      <p:pic>
        <p:nvPicPr>
          <p:cNvPr id="28" name="Picture 27">
            <a:extLst>
              <a:ext uri="{FF2B5EF4-FFF2-40B4-BE49-F238E27FC236}">
                <a16:creationId xmlns:a16="http://schemas.microsoft.com/office/drawing/2014/main" id="{F4153F66-49E9-4CFA-A56B-51D7B9BB28B1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68411" y="3674661"/>
            <a:ext cx="3323589" cy="2743200"/>
          </a:xfrm>
          <a:prstGeom prst="rect">
            <a:avLst/>
          </a:prstGeom>
        </p:spPr>
      </p:pic>
      <p:pic>
        <p:nvPicPr>
          <p:cNvPr id="32" name="Picture 31">
            <a:extLst>
              <a:ext uri="{FF2B5EF4-FFF2-40B4-BE49-F238E27FC236}">
                <a16:creationId xmlns:a16="http://schemas.microsoft.com/office/drawing/2014/main" id="{464E31F7-0243-47DA-8904-13B4C36E2CA6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05802" y="702861"/>
            <a:ext cx="3323589" cy="2743200"/>
          </a:xfrm>
          <a:prstGeom prst="rect">
            <a:avLst/>
          </a:prstGeom>
        </p:spPr>
      </p:pic>
      <p:sp>
        <p:nvSpPr>
          <p:cNvPr id="41" name="TextBox 40">
            <a:extLst>
              <a:ext uri="{FF2B5EF4-FFF2-40B4-BE49-F238E27FC236}">
                <a16:creationId xmlns:a16="http://schemas.microsoft.com/office/drawing/2014/main" id="{F1FB8C4B-62B4-4D42-A677-BDC18E9DA7BC}"/>
              </a:ext>
            </a:extLst>
          </p:cNvPr>
          <p:cNvSpPr txBox="1"/>
          <p:nvPr/>
        </p:nvSpPr>
        <p:spPr>
          <a:xfrm rot="16200000">
            <a:off x="156344" y="1896618"/>
            <a:ext cx="27295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err="1"/>
              <a:t>pC</a:t>
            </a:r>
            <a:r>
              <a:rPr lang="en-US" dirty="0"/>
              <a:t>-Empty Vector</a:t>
            </a:r>
          </a:p>
        </p:txBody>
      </p:sp>
      <p:pic>
        <p:nvPicPr>
          <p:cNvPr id="42" name="Picture 41">
            <a:extLst>
              <a:ext uri="{FF2B5EF4-FFF2-40B4-BE49-F238E27FC236}">
                <a16:creationId xmlns:a16="http://schemas.microsoft.com/office/drawing/2014/main" id="{C36ACA3C-1BB2-4097-9C1E-041B63E32161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29422" y="702861"/>
            <a:ext cx="3323589" cy="2743200"/>
          </a:xfrm>
          <a:prstGeom prst="rect">
            <a:avLst/>
          </a:prstGeom>
        </p:spPr>
      </p:pic>
      <p:pic>
        <p:nvPicPr>
          <p:cNvPr id="43" name="Picture 42">
            <a:extLst>
              <a:ext uri="{FF2B5EF4-FFF2-40B4-BE49-F238E27FC236}">
                <a16:creationId xmlns:a16="http://schemas.microsoft.com/office/drawing/2014/main" id="{CC985DE1-15D4-4E56-82CB-F3E812354A93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53041" y="702861"/>
            <a:ext cx="3323589" cy="2743200"/>
          </a:xfrm>
          <a:prstGeom prst="rect">
            <a:avLst/>
          </a:prstGeom>
        </p:spPr>
      </p:pic>
      <p:sp>
        <p:nvSpPr>
          <p:cNvPr id="44" name="TextBox 43">
            <a:extLst>
              <a:ext uri="{FF2B5EF4-FFF2-40B4-BE49-F238E27FC236}">
                <a16:creationId xmlns:a16="http://schemas.microsoft.com/office/drawing/2014/main" id="{F0DCF4E4-DFCE-4662-AD46-53302F5DCB35}"/>
              </a:ext>
            </a:extLst>
          </p:cNvPr>
          <p:cNvSpPr txBox="1"/>
          <p:nvPr/>
        </p:nvSpPr>
        <p:spPr>
          <a:xfrm>
            <a:off x="1805802" y="167186"/>
            <a:ext cx="330822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800" dirty="0"/>
              <a:t>Anti-3xFlag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3DFC9C1E-24F0-4186-BFC6-CF8E95F1CCC4}"/>
              </a:ext>
            </a:extLst>
          </p:cNvPr>
          <p:cNvSpPr txBox="1"/>
          <p:nvPr/>
        </p:nvSpPr>
        <p:spPr>
          <a:xfrm>
            <a:off x="5329422" y="193288"/>
            <a:ext cx="330822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800" dirty="0"/>
              <a:t>DAPI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F4F998C9-62AA-445A-92F8-C0747CCCBE2D}"/>
              </a:ext>
            </a:extLst>
          </p:cNvPr>
          <p:cNvSpPr txBox="1"/>
          <p:nvPr/>
        </p:nvSpPr>
        <p:spPr>
          <a:xfrm>
            <a:off x="8868410" y="193288"/>
            <a:ext cx="330822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800" dirty="0"/>
              <a:t>Merge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49D2B7F9-C21E-4048-BD77-23821F367A13}"/>
              </a:ext>
            </a:extLst>
          </p:cNvPr>
          <p:cNvSpPr txBox="1"/>
          <p:nvPr/>
        </p:nvSpPr>
        <p:spPr>
          <a:xfrm rot="16200000">
            <a:off x="249536" y="4861595"/>
            <a:ext cx="27431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err="1"/>
              <a:t>pC</a:t>
            </a:r>
            <a:r>
              <a:rPr lang="en-US" dirty="0"/>
              <a:t>-TERT</a:t>
            </a:r>
          </a:p>
        </p:txBody>
      </p:sp>
    </p:spTree>
    <p:extLst>
      <p:ext uri="{BB962C8B-B14F-4D97-AF65-F5344CB8AC3E}">
        <p14:creationId xmlns:p14="http://schemas.microsoft.com/office/powerpoint/2010/main" val="138040170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Picture 10">
            <a:extLst>
              <a:ext uri="{FF2B5EF4-FFF2-40B4-BE49-F238E27FC236}">
                <a16:creationId xmlns:a16="http://schemas.microsoft.com/office/drawing/2014/main" id="{415F89A7-5141-4144-BA19-B502709D2EF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98118" y="716507"/>
            <a:ext cx="3323588" cy="2743200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D3F19DDE-BF2C-4B15-B5C5-42A59155017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33264" y="716507"/>
            <a:ext cx="3323588" cy="2743200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69925DBD-D643-4067-B67B-51F2EB41F686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68412" y="716507"/>
            <a:ext cx="3323588" cy="2743200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40169563-6EDE-48AF-9539-54EBFC209CE4}"/>
              </a:ext>
            </a:extLst>
          </p:cNvPr>
          <p:cNvSpPr txBox="1"/>
          <p:nvPr/>
        </p:nvSpPr>
        <p:spPr>
          <a:xfrm rot="16200000">
            <a:off x="156344" y="1896618"/>
            <a:ext cx="27295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pC-LPCAT1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D5BDBF11-E4FE-4AFF-8720-BA6A47C1601E}"/>
              </a:ext>
            </a:extLst>
          </p:cNvPr>
          <p:cNvSpPr txBox="1"/>
          <p:nvPr/>
        </p:nvSpPr>
        <p:spPr>
          <a:xfrm>
            <a:off x="1805802" y="167186"/>
            <a:ext cx="330822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800" dirty="0"/>
              <a:t>Anti-3xFlag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8F448117-2B6C-40FC-B198-C9CFE881917F}"/>
              </a:ext>
            </a:extLst>
          </p:cNvPr>
          <p:cNvSpPr txBox="1"/>
          <p:nvPr/>
        </p:nvSpPr>
        <p:spPr>
          <a:xfrm>
            <a:off x="5329422" y="193288"/>
            <a:ext cx="330822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800" dirty="0"/>
              <a:t>DAPI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83068754-5DC6-4A06-94B3-E9D4F124ABB7}"/>
              </a:ext>
            </a:extLst>
          </p:cNvPr>
          <p:cNvSpPr txBox="1"/>
          <p:nvPr/>
        </p:nvSpPr>
        <p:spPr>
          <a:xfrm>
            <a:off x="8868410" y="193288"/>
            <a:ext cx="330822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800" dirty="0"/>
              <a:t>Merge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4D22D057-7B94-4500-A8F0-EE198B51D9EC}"/>
              </a:ext>
            </a:extLst>
          </p:cNvPr>
          <p:cNvSpPr txBox="1"/>
          <p:nvPr/>
        </p:nvSpPr>
        <p:spPr>
          <a:xfrm rot="16200000">
            <a:off x="149521" y="4865857"/>
            <a:ext cx="27431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pC-TERT_LPCAT1-Fusion</a:t>
            </a:r>
          </a:p>
        </p:txBody>
      </p:sp>
      <p:pic>
        <p:nvPicPr>
          <p:cNvPr id="26" name="Picture 25">
            <a:extLst>
              <a:ext uri="{FF2B5EF4-FFF2-40B4-BE49-F238E27FC236}">
                <a16:creationId xmlns:a16="http://schemas.microsoft.com/office/drawing/2014/main" id="{813C853B-D27C-422A-BC69-F048D5926B56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81209" y="3678923"/>
            <a:ext cx="3323588" cy="2743200"/>
          </a:xfrm>
          <a:prstGeom prst="rect">
            <a:avLst/>
          </a:prstGeom>
        </p:spPr>
      </p:pic>
      <p:pic>
        <p:nvPicPr>
          <p:cNvPr id="28" name="Picture 27">
            <a:extLst>
              <a:ext uri="{FF2B5EF4-FFF2-40B4-BE49-F238E27FC236}">
                <a16:creationId xmlns:a16="http://schemas.microsoft.com/office/drawing/2014/main" id="{96B6A592-1188-42C7-971D-366C259DECE1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14055" y="3678923"/>
            <a:ext cx="3323588" cy="2743200"/>
          </a:xfrm>
          <a:prstGeom prst="rect">
            <a:avLst/>
          </a:prstGeom>
        </p:spPr>
      </p:pic>
      <p:pic>
        <p:nvPicPr>
          <p:cNvPr id="30" name="Picture 29">
            <a:extLst>
              <a:ext uri="{FF2B5EF4-FFF2-40B4-BE49-F238E27FC236}">
                <a16:creationId xmlns:a16="http://schemas.microsoft.com/office/drawing/2014/main" id="{75A07C56-F252-46DB-BB5E-E3EBF655DA61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68412" y="3678923"/>
            <a:ext cx="3323588" cy="27432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522134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8</TotalTime>
  <Words>13</Words>
  <Application>Microsoft Office PowerPoint</Application>
  <PresentationFormat>Widescreen</PresentationFormat>
  <Paragraphs>10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igafoos, Ashley N.</dc:creator>
  <cp:lastModifiedBy>Sigafoos, Ashley N.</cp:lastModifiedBy>
  <cp:revision>6</cp:revision>
  <dcterms:created xsi:type="dcterms:W3CDTF">2021-03-05T15:39:37Z</dcterms:created>
  <dcterms:modified xsi:type="dcterms:W3CDTF">2021-03-05T16:37:59Z</dcterms:modified>
</cp:coreProperties>
</file>